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howGuides="1">
      <p:cViewPr varScale="1">
        <p:scale>
          <a:sx n="70" d="100"/>
          <a:sy n="70" d="100"/>
        </p:scale>
        <p:origin x="-143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A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A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BFF17-05DA-4C8E-B035-C64759A1C9BB}" type="datetimeFigureOut">
              <a:rPr lang="es-AR" smtClean="0"/>
              <a:pPr/>
              <a:t>05/02/2014</a:t>
            </a:fld>
            <a:endParaRPr lang="es-A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9ED7F-6FF2-4E18-9C4B-7969A6E03429}" type="slidenum">
              <a:rPr lang="es-AR" smtClean="0"/>
              <a:pPr/>
              <a:t>‹Nº›</a:t>
            </a:fld>
            <a:endParaRPr lang="es-A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/>
        </p:nvGraphicFramePr>
        <p:xfrm>
          <a:off x="214298" y="571480"/>
          <a:ext cx="8715404" cy="502307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85950"/>
                <a:gridCol w="2421486"/>
                <a:gridCol w="2293422"/>
                <a:gridCol w="2214546"/>
              </a:tblGrid>
              <a:tr h="479005"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dirty="0" smtClean="0"/>
                        <a:t>Control</a:t>
                      </a:r>
                      <a:endParaRPr lang="es-A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dirty="0" smtClean="0"/>
                        <a:t> IL-12</a:t>
                      </a:r>
                      <a:endParaRPr lang="es-A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dirty="0" smtClean="0"/>
                        <a:t>IL-12+IL-18</a:t>
                      </a:r>
                      <a:endParaRPr lang="es-AR" dirty="0"/>
                    </a:p>
                  </a:txBody>
                  <a:tcPr/>
                </a:tc>
              </a:tr>
              <a:tr h="748035">
                <a:tc>
                  <a:txBody>
                    <a:bodyPr/>
                    <a:lstStyle/>
                    <a:p>
                      <a:r>
                        <a:rPr lang="es-MX" b="1" dirty="0" smtClean="0"/>
                        <a:t>Mandibular </a:t>
                      </a:r>
                      <a:r>
                        <a:rPr lang="es-MX" b="1" dirty="0" err="1" smtClean="0"/>
                        <a:t>LNs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smtClean="0">
                          <a:sym typeface="Symbol"/>
                        </a:rPr>
                        <a:t></a:t>
                      </a:r>
                      <a:r>
                        <a:rPr lang="es-MX" sz="1600" smtClean="0"/>
                        <a:t>Minimal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hyperplasia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oderate</a:t>
                      </a:r>
                      <a:r>
                        <a:rPr lang="es-MX" sz="1600" b="1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</a:tr>
              <a:tr h="748035">
                <a:tc>
                  <a:txBody>
                    <a:bodyPr/>
                    <a:lstStyle/>
                    <a:p>
                      <a:r>
                        <a:rPr lang="es-MX" b="1" dirty="0" err="1" smtClean="0"/>
                        <a:t>Mesenteric</a:t>
                      </a:r>
                      <a:r>
                        <a:rPr lang="es-MX" b="1" dirty="0" smtClean="0"/>
                        <a:t> </a:t>
                      </a:r>
                      <a:r>
                        <a:rPr lang="es-MX" b="1" dirty="0" err="1" smtClean="0"/>
                        <a:t>LNs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inimal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hyperplasia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arked</a:t>
                      </a:r>
                      <a:r>
                        <a:rPr lang="es-MX" sz="1600" b="1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oderate</a:t>
                      </a:r>
                      <a:r>
                        <a:rPr lang="es-MX" sz="1600" b="1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</a:tr>
              <a:tr h="479005">
                <a:tc>
                  <a:txBody>
                    <a:bodyPr/>
                    <a:lstStyle/>
                    <a:p>
                      <a:r>
                        <a:rPr lang="es-MX" b="1" dirty="0" err="1" smtClean="0"/>
                        <a:t>LNs</a:t>
                      </a:r>
                      <a:r>
                        <a:rPr lang="es-MX" b="1" dirty="0" smtClean="0"/>
                        <a:t> NOS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smtClean="0"/>
                        <a:t>Normal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b="1" dirty="0" err="1" smtClean="0"/>
                        <a:t>Moderate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baseline="0" dirty="0" err="1" smtClean="0"/>
                        <a:t>histiocytosis</a:t>
                      </a:r>
                      <a:endParaRPr lang="es-AR" sz="1600" dirty="0"/>
                    </a:p>
                  </a:txBody>
                  <a:tcPr/>
                </a:tc>
              </a:tr>
              <a:tr h="748035">
                <a:tc>
                  <a:txBody>
                    <a:bodyPr/>
                    <a:lstStyle/>
                    <a:p>
                      <a:r>
                        <a:rPr lang="es-MX" b="1" dirty="0" err="1" smtClean="0"/>
                        <a:t>Thymus</a:t>
                      </a:r>
                      <a:r>
                        <a:rPr lang="es-MX" b="1" dirty="0" smtClean="0"/>
                        <a:t> 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smtClean="0"/>
                        <a:t>Normal</a:t>
                      </a:r>
                      <a:endParaRPr lang="es-AR" sz="1600" dirty="0" smtClean="0"/>
                    </a:p>
                    <a:p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atrophy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atrophy</a:t>
                      </a:r>
                      <a:endParaRPr lang="es-AR" sz="1600" dirty="0" smtClean="0"/>
                    </a:p>
                    <a:p>
                      <a:endParaRPr lang="es-AR" sz="1600" dirty="0"/>
                    </a:p>
                  </a:txBody>
                  <a:tcPr/>
                </a:tc>
              </a:tr>
              <a:tr h="748035">
                <a:tc>
                  <a:txBody>
                    <a:bodyPr/>
                    <a:lstStyle/>
                    <a:p>
                      <a:r>
                        <a:rPr lang="es-MX" b="1" dirty="0" err="1" smtClean="0"/>
                        <a:t>Spleen</a:t>
                      </a:r>
                      <a:r>
                        <a:rPr lang="es-MX" b="1" dirty="0" smtClean="0"/>
                        <a:t> 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smtClean="0"/>
                        <a:t>Normal</a:t>
                      </a:r>
                      <a:endParaRPr lang="es-AR" sz="1600" dirty="0" smtClean="0"/>
                    </a:p>
                    <a:p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/>
                        <a:t>Marke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Lymphoid</a:t>
                      </a:r>
                      <a:r>
                        <a:rPr lang="es-MX" sz="1600" dirty="0" smtClean="0"/>
                        <a:t> </a:t>
                      </a:r>
                      <a:r>
                        <a:rPr lang="es-MX" sz="1600" dirty="0" err="1" smtClean="0"/>
                        <a:t>depletion</a:t>
                      </a:r>
                      <a:endParaRPr lang="es-MX" sz="1600" dirty="0" smtClean="0"/>
                    </a:p>
                  </a:txBody>
                  <a:tcPr/>
                </a:tc>
              </a:tr>
              <a:tr h="479005">
                <a:tc>
                  <a:txBody>
                    <a:bodyPr/>
                    <a:lstStyle/>
                    <a:p>
                      <a:r>
                        <a:rPr lang="es-MX" b="1" dirty="0" err="1" smtClean="0"/>
                        <a:t>Liver</a:t>
                      </a:r>
                      <a:endParaRPr lang="es-AR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smtClean="0"/>
                        <a:t>Normal</a:t>
                      </a:r>
                      <a:endParaRPr lang="es-AR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>
                          <a:sym typeface="Symbol"/>
                        </a:rPr>
                        <a:t>Moderate</a:t>
                      </a:r>
                      <a:r>
                        <a:rPr lang="es-MX" sz="1600" dirty="0" smtClean="0">
                          <a:sym typeface="Symbol"/>
                        </a:rPr>
                        <a:t> </a:t>
                      </a:r>
                      <a:r>
                        <a:rPr lang="es-MX" sz="1600" dirty="0" err="1" smtClean="0">
                          <a:sym typeface="Symbol"/>
                        </a:rPr>
                        <a:t>histiocytosis</a:t>
                      </a:r>
                      <a:endParaRPr lang="es-MX" sz="16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600" dirty="0" smtClean="0">
                          <a:sym typeface="Symbol"/>
                        </a:rPr>
                        <a:t></a:t>
                      </a:r>
                      <a:r>
                        <a:rPr lang="es-MX" sz="1600" dirty="0" err="1" smtClean="0">
                          <a:sym typeface="Symbol"/>
                        </a:rPr>
                        <a:t>Moderate</a:t>
                      </a:r>
                      <a:r>
                        <a:rPr lang="es-MX" sz="1600" dirty="0" smtClean="0">
                          <a:sym typeface="Symbol"/>
                        </a:rPr>
                        <a:t> </a:t>
                      </a:r>
                      <a:r>
                        <a:rPr lang="es-MX" sz="1600" dirty="0" err="1" smtClean="0">
                          <a:sym typeface="Symbol"/>
                        </a:rPr>
                        <a:t>histiocytosis</a:t>
                      </a:r>
                      <a:endParaRPr lang="es-MX" sz="1600" dirty="0" smtClean="0"/>
                    </a:p>
                    <a:p>
                      <a:endParaRPr lang="es-MX" sz="1600" dirty="0" smtClean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5 CuadroTexto"/>
          <p:cNvSpPr txBox="1"/>
          <p:nvPr/>
        </p:nvSpPr>
        <p:spPr>
          <a:xfrm>
            <a:off x="142908" y="285728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 err="1" smtClean="0">
                <a:latin typeface="Arial" pitchFamily="34" charset="0"/>
                <a:cs typeface="Arial" pitchFamily="34" charset="0"/>
              </a:rPr>
              <a:t>Table</a:t>
            </a:r>
            <a:r>
              <a:rPr lang="es-MX" sz="16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1600" b="1" dirty="0" smtClean="0">
                <a:latin typeface="Arial" pitchFamily="34" charset="0"/>
                <a:cs typeface="Arial" pitchFamily="34" charset="0"/>
              </a:rPr>
              <a:t> S1</a:t>
            </a:r>
            <a:r>
              <a:rPr lang="es-MX" sz="1600" b="1" dirty="0" smtClean="0">
                <a:latin typeface="Arial" pitchFamily="34" charset="0"/>
                <a:cs typeface="Arial" pitchFamily="34" charset="0"/>
              </a:rPr>
              <a:t>. </a:t>
            </a:r>
            <a:endParaRPr lang="es-A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EBEBEB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94</Words>
  <Application>Microsoft Office PowerPoint</Application>
  <PresentationFormat>Presentación en pantalla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E</dc:creator>
  <cp:lastModifiedBy>CE</cp:lastModifiedBy>
  <cp:revision>4</cp:revision>
  <dcterms:created xsi:type="dcterms:W3CDTF">2013-08-08T00:26:56Z</dcterms:created>
  <dcterms:modified xsi:type="dcterms:W3CDTF">2014-02-06T00:22:57Z</dcterms:modified>
</cp:coreProperties>
</file>